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90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55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7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015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95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769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804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371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0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944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520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784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DB32D-4DA5-4C14-919B-BB6F8DBB4FE0}" type="datetimeFigureOut">
              <a:rPr lang="en-US" smtClean="0"/>
              <a:t>2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29CD4-24FE-416B-9E16-C674225012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331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s for assessment of publication bias and small study effec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813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s for overall toxicity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600200"/>
            <a:ext cx="6305804" cy="4614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192993" y="3200400"/>
            <a:ext cx="20521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572 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29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61943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Partial Respons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1417627"/>
            <a:ext cx="5754457" cy="42118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086600" y="3200400"/>
            <a:ext cx="20521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601 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28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22632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Stable Diseas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1524000"/>
            <a:ext cx="5725936" cy="419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858000" y="2971800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1 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020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8003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Progressive Diseas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199" y="1524000"/>
            <a:ext cx="6143115" cy="4495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979876" y="3085379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135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03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81439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b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Exploration Rates (Explored/N)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1752600"/>
            <a:ext cx="5117123" cy="37453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248400" y="2895600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234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085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7418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Resection Rates (Resected /N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321" y="1752600"/>
            <a:ext cx="6248400" cy="45728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043468" y="2904226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528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457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01350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for Overall Surgical Morbidity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1741098"/>
            <a:ext cx="5114925" cy="3743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629400" y="2581060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548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15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78390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</a:t>
            </a:r>
            <a:b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de 3 or highe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gical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bidity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677838"/>
            <a:ext cx="5622513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477000" y="2591448"/>
            <a:ext cx="20392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gg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st p = 0.592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ger test p = 0.53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4297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115</Words>
  <Application>Microsoft Office PowerPoint</Application>
  <PresentationFormat>On-screen Show (4:3)</PresentationFormat>
  <Paragraphs>25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Funnel plots for assessment of publication bias and small study effects</vt:lpstr>
      <vt:lpstr>Supplementary Figure 1 Funnel plots for overall toxicity</vt:lpstr>
      <vt:lpstr>Supplementary Figure 2 Funnel plot for Partial Response</vt:lpstr>
      <vt:lpstr>Supplementary Figure 3 Funnel plot for Stable Disease</vt:lpstr>
      <vt:lpstr>Supplementary Figure 4 Funnel plot for Progressive Disease</vt:lpstr>
      <vt:lpstr>Supplementary Figure 5 Funnel plot for Exploration Rates (Explored/N)</vt:lpstr>
      <vt:lpstr>Supplementary Figure 6 Funnel plot for Resection Rates (Resected /N)</vt:lpstr>
      <vt:lpstr>Supplementary Figure 7 Funnel plot for Overall Surgical Morbidity</vt:lpstr>
      <vt:lpstr>Supplementary Figure 8 Grade 3 or higher Surgical Morbidity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nnel plots</dc:title>
  <dc:creator>Mashaal Dhir</dc:creator>
  <cp:lastModifiedBy>Mashaal Dhir</cp:lastModifiedBy>
  <cp:revision>7</cp:revision>
  <dcterms:created xsi:type="dcterms:W3CDTF">2017-02-19T16:37:58Z</dcterms:created>
  <dcterms:modified xsi:type="dcterms:W3CDTF">2017-02-19T17:38:20Z</dcterms:modified>
</cp:coreProperties>
</file>